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98"/>
    <p:restoredTop sz="94574"/>
  </p:normalViewPr>
  <p:slideViewPr>
    <p:cSldViewPr snapToGrid="0" snapToObjects="1" showGuides="1">
      <p:cViewPr varScale="1">
        <p:scale>
          <a:sx n="91" d="100"/>
          <a:sy n="91" d="100"/>
        </p:scale>
        <p:origin x="200" y="7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744DF7-7E64-6D46-9343-46E4DBCD06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967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7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99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54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6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20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65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5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46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36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71D9888-CC33-644F-8FED-2A74310EED60}"/>
              </a:ext>
            </a:extLst>
          </p:cNvPr>
          <p:cNvSpPr/>
          <p:nvPr/>
        </p:nvSpPr>
        <p:spPr>
          <a:xfrm>
            <a:off x="546411" y="137059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239042-7868-AB42-A5BF-DBBBFA527A23}"/>
              </a:ext>
            </a:extLst>
          </p:cNvPr>
          <p:cNvSpPr/>
          <p:nvPr/>
        </p:nvSpPr>
        <p:spPr>
          <a:xfrm>
            <a:off x="5085482" y="1370593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1473AC1D-BF60-D442-88A1-000396CE932D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62"/>
          <a:stretch/>
        </p:blipFill>
        <p:spPr bwMode="auto">
          <a:xfrm>
            <a:off x="546411" y="1670675"/>
            <a:ext cx="4376942" cy="32389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ED15FB01-ADD4-824E-A08B-55212B0DB165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133"/>
          <a:stretch/>
        </p:blipFill>
        <p:spPr bwMode="auto">
          <a:xfrm>
            <a:off x="5085482" y="1670675"/>
            <a:ext cx="4376942" cy="32751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A2D56AC-C688-7E46-A541-97A8371A60F5}"/>
              </a:ext>
            </a:extLst>
          </p:cNvPr>
          <p:cNvSpPr txBox="1"/>
          <p:nvPr/>
        </p:nvSpPr>
        <p:spPr>
          <a:xfrm>
            <a:off x="691765" y="5595224"/>
            <a:ext cx="91388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6: Figure S5. Forest plot of 3-month (a) and 6-month (b) PFS with doxorubicin alone vs experimental chemotherapy.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CI, confidence interval; M-H, Mantel-Haenszel; PFS, progression-free survival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4493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45</Words>
  <Application>Microsoft Macintosh PowerPoint</Application>
  <PresentationFormat>A4 210 x 297 mm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>田仲和宏</cp:lastModifiedBy>
  <cp:revision>37</cp:revision>
  <cp:lastPrinted>2018-06-08T06:33:36Z</cp:lastPrinted>
  <dcterms:created xsi:type="dcterms:W3CDTF">2018-05-19T00:24:53Z</dcterms:created>
  <dcterms:modified xsi:type="dcterms:W3CDTF">2018-12-11T05:04:33Z</dcterms:modified>
</cp:coreProperties>
</file>